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4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0986C-7D73-432F-91DE-0D1877B4E219}" type="datetimeFigureOut">
              <a:rPr kumimoji="1" lang="ja-JP" altLang="en-US" smtClean="0"/>
              <a:pPr/>
              <a:t>2022/9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38DE4-D068-4AF8-BEBA-69D90E84345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46775" y="1853825"/>
            <a:ext cx="3332408" cy="25039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テキスト ボックス 4"/>
          <p:cNvSpPr txBox="1"/>
          <p:nvPr/>
        </p:nvSpPr>
        <p:spPr>
          <a:xfrm>
            <a:off x="2117447" y="1887244"/>
            <a:ext cx="450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186735" y="2168860"/>
            <a:ext cx="405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7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188468" y="2490925"/>
            <a:ext cx="405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5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186735" y="2663915"/>
            <a:ext cx="405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4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186735" y="3023955"/>
            <a:ext cx="405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3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186735" y="3609020"/>
            <a:ext cx="405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2</a:t>
            </a:r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186735" y="4014065"/>
            <a:ext cx="405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15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直線コネクタ 15"/>
          <p:cNvCxnSpPr/>
          <p:nvPr/>
        </p:nvCxnSpPr>
        <p:spPr>
          <a:xfrm>
            <a:off x="2546775" y="2033845"/>
            <a:ext cx="2700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2546775" y="2303875"/>
            <a:ext cx="2700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2546775" y="2663915"/>
            <a:ext cx="2700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2546775" y="2798930"/>
            <a:ext cx="2700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2546775" y="3158970"/>
            <a:ext cx="2700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2546775" y="3744035"/>
            <a:ext cx="2700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2545425" y="4172505"/>
            <a:ext cx="2700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566555" y="503675"/>
            <a:ext cx="2700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. 1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916705" y="1133745"/>
            <a:ext cx="40054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T</a:t>
            </a:r>
            <a:r>
              <a:rPr kumimoji="1" lang="en-US" altLang="ja-JP" dirty="0" smtClean="0"/>
              <a:t>reatment</a:t>
            </a:r>
          </a:p>
          <a:p>
            <a:r>
              <a:rPr lang="en-US" altLang="ja-JP" dirty="0" smtClean="0"/>
              <a:t>Time (h)        0            1           3           5        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646675" y="2798930"/>
            <a:ext cx="585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kDa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296525" y="4689140"/>
            <a:ext cx="8235915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. Time course of silkworm Na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-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ase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unit treatment with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Gase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 in denaturing buffer. 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some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40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silkworm nerve were suspended in the denaturing buffer (0.14% SDS, 1% Triton X-100, 10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DTA, 2%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captoethanol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50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 8.6) and 0.2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Gase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 in 40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After incubation for 1, 3 and 5 h at 37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 10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 of the reaction mixture was withdrawn, and frozen. The mixtures were applied to SDP-PAGE and immunoblotting using anti-silkworm Na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TPase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unit antibody. 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1830" y="1943835"/>
            <a:ext cx="2237665" cy="24937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テキスト ボックス 4"/>
          <p:cNvSpPr txBox="1"/>
          <p:nvPr/>
        </p:nvSpPr>
        <p:spPr>
          <a:xfrm>
            <a:off x="2321750" y="1268760"/>
            <a:ext cx="31053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Treatment</a:t>
            </a:r>
          </a:p>
          <a:p>
            <a:r>
              <a:rPr lang="en-US" altLang="ja-JP" dirty="0" smtClean="0"/>
              <a:t>Time (h)          0         3         5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31539" y="323655"/>
            <a:ext cx="27453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. 2 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直線コネクタ 7"/>
          <p:cNvCxnSpPr/>
          <p:nvPr/>
        </p:nvCxnSpPr>
        <p:spPr>
          <a:xfrm>
            <a:off x="3041830" y="2123855"/>
            <a:ext cx="2250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3041830" y="2393885"/>
            <a:ext cx="2250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3041830" y="2753925"/>
            <a:ext cx="2250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3041830" y="2888940"/>
            <a:ext cx="2250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3060946" y="3222594"/>
            <a:ext cx="2250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3041830" y="3789040"/>
            <a:ext cx="2250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3041830" y="4149080"/>
            <a:ext cx="2250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2555046" y="1970845"/>
            <a:ext cx="540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648267" y="2234095"/>
            <a:ext cx="540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itchFamily="34" charset="0"/>
                <a:cs typeface="Arial" pitchFamily="34" charset="0"/>
              </a:rPr>
              <a:t>7</a:t>
            </a:r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658368" y="2587963"/>
            <a:ext cx="540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5</a:t>
            </a:r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668490" y="2762066"/>
            <a:ext cx="540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itchFamily="34" charset="0"/>
                <a:cs typeface="Arial" pitchFamily="34" charset="0"/>
              </a:rPr>
              <a:t>4</a:t>
            </a:r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681790" y="3068960"/>
            <a:ext cx="540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3</a:t>
            </a:r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681790" y="3654025"/>
            <a:ext cx="540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itchFamily="34" charset="0"/>
                <a:cs typeface="Arial" pitchFamily="34" charset="0"/>
              </a:rPr>
              <a:t>2</a:t>
            </a:r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681790" y="4014065"/>
            <a:ext cx="540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15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006715" y="2888940"/>
            <a:ext cx="675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" pitchFamily="34" charset="0"/>
                <a:cs typeface="Arial" pitchFamily="34" charset="0"/>
              </a:rPr>
              <a:t>kDa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431538" y="4644135"/>
            <a:ext cx="8280921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. Time course of silkworm Na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-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ase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unit treatment with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Gase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 in native buffer.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some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5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silkworm nerve were suspended in the native buffer (50mM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 8.6) and 0.5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Gase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 in 25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After incubation for 3 and 5 h at 3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 10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 of the reaction mixture was withdrawn, and frozen. The mixtures were applied to SDP-PAGE and immunoblotting using anti-silkworm Na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-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ase </a:t>
            </a:r>
            <a:r>
              <a:rPr lang="el-GR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unit antibody.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8521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57</Words>
  <Application>Microsoft Office PowerPoint</Application>
  <PresentationFormat>画面に合わせる (4:3)</PresentationFormat>
  <Paragraphs>24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Company>FJ-W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H.Hom</dc:creator>
  <cp:lastModifiedBy>麻酔科医局</cp:lastModifiedBy>
  <cp:revision>16</cp:revision>
  <dcterms:created xsi:type="dcterms:W3CDTF">2022-07-19T07:20:50Z</dcterms:created>
  <dcterms:modified xsi:type="dcterms:W3CDTF">2022-09-10T03:14:36Z</dcterms:modified>
</cp:coreProperties>
</file>